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4" autoAdjust="0"/>
    <p:restoredTop sz="90408" autoAdjust="0"/>
  </p:normalViewPr>
  <p:slideViewPr>
    <p:cSldViewPr snapToGrid="0">
      <p:cViewPr varScale="1">
        <p:scale>
          <a:sx n="55" d="100"/>
          <a:sy n="55" d="100"/>
        </p:scale>
        <p:origin x="500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08D458-6E0D-4954-A07C-81C45EE6E843}" type="datetimeFigureOut">
              <a:rPr lang="en-US" smtClean="0"/>
              <a:t>4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39C32-D182-4170-88AC-EBCB0F529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54864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08D458-6E0D-4954-A07C-81C45EE6E843}" type="datetimeFigureOut">
              <a:rPr lang="en-US" smtClean="0"/>
              <a:t>4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39C32-D182-4170-88AC-EBCB0F529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09945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08D458-6E0D-4954-A07C-81C45EE6E843}" type="datetimeFigureOut">
              <a:rPr lang="en-US" smtClean="0"/>
              <a:t>4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39C32-D182-4170-88AC-EBCB0F529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67786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08D458-6E0D-4954-A07C-81C45EE6E843}" type="datetimeFigureOut">
              <a:rPr lang="en-US" smtClean="0"/>
              <a:t>4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39C32-D182-4170-88AC-EBCB0F529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46723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08D458-6E0D-4954-A07C-81C45EE6E843}" type="datetimeFigureOut">
              <a:rPr lang="en-US" smtClean="0"/>
              <a:t>4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39C32-D182-4170-88AC-EBCB0F529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82617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08D458-6E0D-4954-A07C-81C45EE6E843}" type="datetimeFigureOut">
              <a:rPr lang="en-US" smtClean="0"/>
              <a:t>4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39C32-D182-4170-88AC-EBCB0F529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01282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08D458-6E0D-4954-A07C-81C45EE6E843}" type="datetimeFigureOut">
              <a:rPr lang="en-US" smtClean="0"/>
              <a:t>4/21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39C32-D182-4170-88AC-EBCB0F529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31229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08D458-6E0D-4954-A07C-81C45EE6E843}" type="datetimeFigureOut">
              <a:rPr lang="en-US" smtClean="0"/>
              <a:t>4/21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39C32-D182-4170-88AC-EBCB0F529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06024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08D458-6E0D-4954-A07C-81C45EE6E843}" type="datetimeFigureOut">
              <a:rPr lang="en-US" smtClean="0"/>
              <a:t>4/21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39C32-D182-4170-88AC-EBCB0F529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5980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08D458-6E0D-4954-A07C-81C45EE6E843}" type="datetimeFigureOut">
              <a:rPr lang="en-US" smtClean="0"/>
              <a:t>4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39C32-D182-4170-88AC-EBCB0F529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07625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08D458-6E0D-4954-A07C-81C45EE6E843}" type="datetimeFigureOut">
              <a:rPr lang="en-US" smtClean="0"/>
              <a:t>4/21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39C32-D182-4170-88AC-EBCB0F529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981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08D458-6E0D-4954-A07C-81C45EE6E843}" type="datetimeFigureOut">
              <a:rPr lang="en-US" smtClean="0"/>
              <a:t>4/21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F39C32-D182-4170-88AC-EBCB0F529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81537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l="5897" t="5579" r="25607" b="13414"/>
          <a:stretch/>
        </p:blipFill>
        <p:spPr>
          <a:xfrm>
            <a:off x="403221" y="1589500"/>
            <a:ext cx="4905609" cy="455787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/>
          <a:srcRect l="5965" t="6406" r="25943" b="13374"/>
          <a:stretch/>
        </p:blipFill>
        <p:spPr>
          <a:xfrm>
            <a:off x="6606124" y="1379638"/>
            <a:ext cx="5281076" cy="4775227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 rot="16200000">
            <a:off x="-1855611" y="3578904"/>
            <a:ext cx="422476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Average Electric Field </a:t>
            </a:r>
            <a:r>
              <a:rPr lang="en-US" sz="1600" dirty="0" smtClean="0"/>
              <a:t>Magnitude</a:t>
            </a:r>
            <a:r>
              <a:rPr lang="en-US" sz="1600" dirty="0" smtClean="0"/>
              <a:t>: </a:t>
            </a:r>
            <a:r>
              <a:rPr lang="en-US" sz="1600" dirty="0" smtClean="0"/>
              <a:t>All Sites (V/m)</a:t>
            </a:r>
            <a:endParaRPr lang="en-US" sz="1600" dirty="0"/>
          </a:p>
        </p:txBody>
      </p:sp>
      <p:sp>
        <p:nvSpPr>
          <p:cNvPr id="13" name="TextBox 12"/>
          <p:cNvSpPr txBox="1"/>
          <p:nvPr/>
        </p:nvSpPr>
        <p:spPr>
          <a:xfrm rot="16200000">
            <a:off x="4337823" y="3578903"/>
            <a:ext cx="42247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Average Electric Field </a:t>
            </a:r>
            <a:r>
              <a:rPr lang="en-US" sz="1600" dirty="0" smtClean="0"/>
              <a:t>Magnitude</a:t>
            </a:r>
            <a:r>
              <a:rPr lang="en-US" sz="1600" dirty="0" smtClean="0"/>
              <a:t>: </a:t>
            </a:r>
            <a:r>
              <a:rPr lang="en-US" sz="1600" dirty="0" smtClean="0"/>
              <a:t>All Sites (V/m)</a:t>
            </a:r>
            <a:endParaRPr lang="en-US" sz="1600" dirty="0"/>
          </a:p>
        </p:txBody>
      </p:sp>
      <p:sp>
        <p:nvSpPr>
          <p:cNvPr id="14" name="TextBox 13"/>
          <p:cNvSpPr txBox="1"/>
          <p:nvPr/>
        </p:nvSpPr>
        <p:spPr>
          <a:xfrm>
            <a:off x="2741118" y="6159500"/>
            <a:ext cx="5492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ge</a:t>
            </a:r>
            <a:endParaRPr lang="en-US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9149412" y="6171630"/>
            <a:ext cx="5567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ge</a:t>
            </a:r>
            <a:endParaRPr lang="en-US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2532505" y="1115013"/>
            <a:ext cx="121503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Females </a:t>
            </a:r>
            <a:r>
              <a:rPr lang="en-US" b="1" dirty="0">
                <a:latin typeface="Malgun Gothic" panose="020B0503020000020004" pitchFamily="34" charset="-127"/>
                <a:ea typeface="Malgun Gothic" panose="020B0503020000020004" pitchFamily="34" charset="-127"/>
              </a:rPr>
              <a:t>♀</a:t>
            </a:r>
            <a:endParaRPr lang="en-US" b="1" dirty="0"/>
          </a:p>
          <a:p>
            <a:endParaRPr lang="en-US" b="1" dirty="0"/>
          </a:p>
        </p:txBody>
      </p:sp>
      <p:sp>
        <p:nvSpPr>
          <p:cNvPr id="18" name="Rectangle 17"/>
          <p:cNvSpPr/>
          <p:nvPr/>
        </p:nvSpPr>
        <p:spPr>
          <a:xfrm>
            <a:off x="9215452" y="1115013"/>
            <a:ext cx="98135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/>
              <a:t>Males </a:t>
            </a:r>
            <a:r>
              <a:rPr lang="en-US" b="1" dirty="0" smtClean="0">
                <a:latin typeface="Malgun Gothic" panose="020B0503020000020004" pitchFamily="34" charset="-127"/>
                <a:ea typeface="Malgun Gothic" panose="020B0503020000020004" pitchFamily="34" charset="-127"/>
              </a:rPr>
              <a:t>♂</a:t>
            </a:r>
            <a:endParaRPr lang="en-US" b="1" dirty="0"/>
          </a:p>
        </p:txBody>
      </p:sp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4"/>
          <a:srcRect l="68150" t="9772" r="2271" b="78362"/>
          <a:stretch/>
        </p:blipFill>
        <p:spPr>
          <a:xfrm>
            <a:off x="4290900" y="1879268"/>
            <a:ext cx="1885047" cy="594109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 rotWithShape="1">
          <a:blip r:embed="rId4"/>
          <a:srcRect l="68150" t="9772" b="78679"/>
          <a:stretch/>
        </p:blipFill>
        <p:spPr>
          <a:xfrm>
            <a:off x="10131593" y="1879268"/>
            <a:ext cx="2029812" cy="5782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654188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5</TotalTime>
  <Words>26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Malgun Gothic</vt:lpstr>
      <vt:lpstr>Arial</vt:lpstr>
      <vt:lpstr>Calibri</vt:lpstr>
      <vt:lpstr>Calibri Light</vt:lpstr>
      <vt:lpstr>Office Theme</vt:lpstr>
      <vt:lpstr>PowerPoint Presentation</vt:lpstr>
    </vt:vector>
  </TitlesOfParts>
  <Company>WFB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itlin Roberta Kinney</dc:creator>
  <cp:lastModifiedBy>Kaitlin Kinney</cp:lastModifiedBy>
  <cp:revision>6</cp:revision>
  <dcterms:created xsi:type="dcterms:W3CDTF">2025-09-15T15:16:18Z</dcterms:created>
  <dcterms:modified xsi:type="dcterms:W3CDTF">2026-04-21T19:08:52Z</dcterms:modified>
</cp:coreProperties>
</file>